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6" r:id="rId2"/>
  </p:sldIdLst>
  <p:sldSz cx="6858000" cy="9906000" type="A4"/>
  <p:notesSz cx="7099300" cy="10234613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6699"/>
    <a:srgbClr val="000000"/>
    <a:srgbClr val="60A0DA"/>
    <a:srgbClr val="EC7728"/>
    <a:srgbClr val="EE8640"/>
    <a:srgbClr val="9D999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029" autoAdjust="0"/>
    <p:restoredTop sz="94660"/>
  </p:normalViewPr>
  <p:slideViewPr>
    <p:cSldViewPr snapToGrid="0">
      <p:cViewPr varScale="1">
        <p:scale>
          <a:sx n="49" d="100"/>
          <a:sy n="49" d="100"/>
        </p:scale>
        <p:origin x="244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51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2681;&#22823;&#37291;&#38498;\Paper\BMC%20Microbiology\Revision\12&#24180;&#20998;&#26512;&#26356;&#26032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Age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每一年不同抗藥性程度比例及其和性別年紀的關係!$I$85:$M$85</c:f>
                <c:numCache>
                  <c:formatCode>General</c:formatCode>
                  <c:ptCount val="5"/>
                  <c:pt idx="0">
                    <c:v>20.910364443670634</c:v>
                  </c:pt>
                  <c:pt idx="1">
                    <c:v>21.571668826633015</c:v>
                  </c:pt>
                  <c:pt idx="2">
                    <c:v>20.526646212071771</c:v>
                  </c:pt>
                  <c:pt idx="3">
                    <c:v>23.353077338034662</c:v>
                  </c:pt>
                  <c:pt idx="4">
                    <c:v>20.921852149578623</c:v>
                  </c:pt>
                </c:numCache>
              </c:numRef>
            </c:plus>
            <c:minus>
              <c:numRef>
                <c:f>每一年不同抗藥性程度比例及其和性別年紀的關係!$I$85:$M$85</c:f>
                <c:numCache>
                  <c:formatCode>General</c:formatCode>
                  <c:ptCount val="5"/>
                  <c:pt idx="0">
                    <c:v>20.910364443670634</c:v>
                  </c:pt>
                  <c:pt idx="1">
                    <c:v>21.571668826633015</c:v>
                  </c:pt>
                  <c:pt idx="2">
                    <c:v>20.526646212071771</c:v>
                  </c:pt>
                  <c:pt idx="3">
                    <c:v>23.353077338034662</c:v>
                  </c:pt>
                  <c:pt idx="4">
                    <c:v>20.92185214957862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每一年不同抗藥性程度比例及其和性別年紀的關係!$B$71:$B$75</c:f>
              <c:strCache>
                <c:ptCount val="5"/>
                <c:pt idx="0">
                  <c:v>NR</c:v>
                </c:pt>
                <c:pt idx="1">
                  <c:v>SDR</c:v>
                </c:pt>
                <c:pt idx="2">
                  <c:v>TDR</c:v>
                </c:pt>
                <c:pt idx="3">
                  <c:v>MDR</c:v>
                </c:pt>
                <c:pt idx="4">
                  <c:v>XDR</c:v>
                </c:pt>
              </c:strCache>
            </c:strRef>
          </c:cat>
          <c:val>
            <c:numRef>
              <c:f>每一年不同抗藥性程度比例及其和性別年紀的關係!$I$84:$M$84</c:f>
              <c:numCache>
                <c:formatCode>####.0000</c:formatCode>
                <c:ptCount val="5"/>
                <c:pt idx="0">
                  <c:v>66.586125670014439</c:v>
                </c:pt>
                <c:pt idx="1">
                  <c:v>67.175561643822249</c:v>
                </c:pt>
                <c:pt idx="2">
                  <c:v>68.330540460778124</c:v>
                </c:pt>
                <c:pt idx="3">
                  <c:v>64.70626625330253</c:v>
                </c:pt>
                <c:pt idx="4">
                  <c:v>64.64119072673075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52346312"/>
        <c:axId val="452345528"/>
      </c:barChart>
      <c:lineChart>
        <c:grouping val="standard"/>
        <c:varyColors val="0"/>
        <c:ser>
          <c:idx val="1"/>
          <c:order val="1"/>
          <c:tx>
            <c:v>Male%</c:v>
          </c:tx>
          <c:spPr>
            <a:ln w="38100" cap="rnd">
              <a:solidFill>
                <a:srgbClr val="C00000"/>
              </a:solidFill>
              <a:round/>
            </a:ln>
            <a:effectLst/>
          </c:spPr>
          <c:marker>
            <c:symbol val="none"/>
          </c:marker>
          <c:val>
            <c:numRef>
              <c:f>每一年不同抗藥性程度比例及其和性別年紀的關係!$I$87:$M$87</c:f>
              <c:numCache>
                <c:formatCode>General</c:formatCode>
                <c:ptCount val="5"/>
                <c:pt idx="0">
                  <c:v>72.101449275362313</c:v>
                </c:pt>
                <c:pt idx="1">
                  <c:v>69.333333333333343</c:v>
                </c:pt>
                <c:pt idx="2">
                  <c:v>68.708609271523187</c:v>
                </c:pt>
                <c:pt idx="3">
                  <c:v>63.279445727482674</c:v>
                </c:pt>
                <c:pt idx="4">
                  <c:v>71.15384615384616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52346312"/>
        <c:axId val="452345528"/>
      </c:lineChart>
      <c:catAx>
        <c:axId val="4523463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TW"/>
          </a:p>
        </c:txPr>
        <c:crossAx val="452345528"/>
        <c:crosses val="autoZero"/>
        <c:auto val="1"/>
        <c:lblAlgn val="ctr"/>
        <c:lblOffset val="100"/>
        <c:noMultiLvlLbl val="0"/>
      </c:catAx>
      <c:valAx>
        <c:axId val="452345528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,##0_);[Red]\(#,##0\)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TW"/>
          </a:p>
        </c:txPr>
        <c:crossAx val="45234631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TW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zh-TW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6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Arial Unicode MS" panose="020B0604020202020204" pitchFamily="34" charset="-120"/>
                <a:cs typeface="Arial" panose="020B0604020202020204" pitchFamily="34" charset="0"/>
              </a:defRPr>
            </a:pPr>
            <a:r>
              <a:rPr lang="en-US"/>
              <a:t>Hospital-acquired infection</a:t>
            </a:r>
            <a:endParaRPr lang="zh-TW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6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Arial Unicode MS" panose="020B0604020202020204" pitchFamily="34" charset="-120"/>
              <a:cs typeface="Arial" panose="020B0604020202020204" pitchFamily="34" charset="0"/>
            </a:defRPr>
          </a:pPr>
          <a:endParaRPr lang="zh-TW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不同抗藥性程度和檢體別集檢體來源的關係!$W$4:$Z$4</c:f>
              <c:strCache>
                <c:ptCount val="4"/>
                <c:pt idx="0">
                  <c:v>SDR</c:v>
                </c:pt>
                <c:pt idx="1">
                  <c:v>TDR</c:v>
                </c:pt>
                <c:pt idx="2">
                  <c:v>MDR</c:v>
                </c:pt>
                <c:pt idx="3">
                  <c:v>XDR</c:v>
                </c:pt>
              </c:strCache>
            </c:strRef>
          </c:cat>
          <c:val>
            <c:numRef>
              <c:f>不同抗藥性程度和檢體別集檢體來源的關係!$W$10:$Z$10</c:f>
              <c:numCache>
                <c:formatCode>0.00%</c:formatCode>
                <c:ptCount val="4"/>
                <c:pt idx="0">
                  <c:v>0.14222222222222222</c:v>
                </c:pt>
                <c:pt idx="1">
                  <c:v>0.12108559498956159</c:v>
                </c:pt>
                <c:pt idx="2">
                  <c:v>0.13644524236983843</c:v>
                </c:pt>
                <c:pt idx="3">
                  <c:v>5.7692307692307696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52345920"/>
        <c:axId val="452348272"/>
      </c:barChart>
      <c:catAx>
        <c:axId val="452345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 Unicode MS" panose="020B0604020202020204" pitchFamily="34" charset="-120"/>
                <a:cs typeface="Arial" panose="020B0604020202020204" pitchFamily="34" charset="0"/>
              </a:defRPr>
            </a:pPr>
            <a:endParaRPr lang="zh-TW"/>
          </a:p>
        </c:txPr>
        <c:crossAx val="452348272"/>
        <c:crosses val="autoZero"/>
        <c:auto val="1"/>
        <c:lblAlgn val="ctr"/>
        <c:lblOffset val="100"/>
        <c:noMultiLvlLbl val="0"/>
      </c:catAx>
      <c:valAx>
        <c:axId val="452348272"/>
        <c:scaling>
          <c:orientation val="minMax"/>
          <c:max val="0.2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 Unicode MS" panose="020B0604020202020204" pitchFamily="34" charset="-120"/>
                <a:cs typeface="Arial" panose="020B0604020202020204" pitchFamily="34" charset="0"/>
              </a:defRPr>
            </a:pPr>
            <a:endParaRPr lang="zh-TW"/>
          </a:p>
        </c:txPr>
        <c:crossAx val="452345920"/>
        <c:crosses val="autoZero"/>
        <c:crossBetween val="between"/>
        <c:majorUnit val="5.000000000000001E-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800">
          <a:solidFill>
            <a:schemeClr val="tx1"/>
          </a:solidFill>
          <a:latin typeface="Arial" panose="020B0604020202020204" pitchFamily="34" charset="0"/>
          <a:ea typeface="Arial Unicode MS" panose="020B0604020202020204" pitchFamily="34" charset="-120"/>
          <a:cs typeface="Arial" panose="020B0604020202020204" pitchFamily="34" charset="0"/>
        </a:defRPr>
      </a:pPr>
      <a:endParaRPr lang="zh-TW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TW" altLang="en-US" smtClean="0"/>
              <a:t>按一下以編輯母片副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16FF3-EC6F-4384-83EE-D1B9E4DE6173}" type="datetimeFigureOut">
              <a:rPr lang="zh-TW" altLang="en-US" smtClean="0"/>
              <a:t>2020/3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756B7-59D5-49D3-8B1A-DF5E309A7ED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5139588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16FF3-EC6F-4384-83EE-D1B9E4DE6173}" type="datetimeFigureOut">
              <a:rPr lang="zh-TW" altLang="en-US" smtClean="0"/>
              <a:t>2020/3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756B7-59D5-49D3-8B1A-DF5E309A7ED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59353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16FF3-EC6F-4384-83EE-D1B9E4DE6173}" type="datetimeFigureOut">
              <a:rPr lang="zh-TW" altLang="en-US" smtClean="0"/>
              <a:t>2020/3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756B7-59D5-49D3-8B1A-DF5E309A7ED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194724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16FF3-EC6F-4384-83EE-D1B9E4DE6173}" type="datetimeFigureOut">
              <a:rPr lang="zh-TW" altLang="en-US" smtClean="0"/>
              <a:t>2020/3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756B7-59D5-49D3-8B1A-DF5E309A7ED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6856532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16FF3-EC6F-4384-83EE-D1B9E4DE6173}" type="datetimeFigureOut">
              <a:rPr lang="zh-TW" altLang="en-US" smtClean="0"/>
              <a:t>2020/3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756B7-59D5-49D3-8B1A-DF5E309A7ED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900826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16FF3-EC6F-4384-83EE-D1B9E4DE6173}" type="datetimeFigureOut">
              <a:rPr lang="zh-TW" altLang="en-US" smtClean="0"/>
              <a:t>2020/3/2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756B7-59D5-49D3-8B1A-DF5E309A7ED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757870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16FF3-EC6F-4384-83EE-D1B9E4DE6173}" type="datetimeFigureOut">
              <a:rPr lang="zh-TW" altLang="en-US" smtClean="0"/>
              <a:t>2020/3/29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756B7-59D5-49D3-8B1A-DF5E309A7ED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546456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16FF3-EC6F-4384-83EE-D1B9E4DE6173}" type="datetimeFigureOut">
              <a:rPr lang="zh-TW" altLang="en-US" smtClean="0"/>
              <a:t>2020/3/29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756B7-59D5-49D3-8B1A-DF5E309A7ED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316386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16FF3-EC6F-4384-83EE-D1B9E4DE6173}" type="datetimeFigureOut">
              <a:rPr lang="zh-TW" altLang="en-US" smtClean="0"/>
              <a:t>2020/3/29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756B7-59D5-49D3-8B1A-DF5E309A7ED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092411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16FF3-EC6F-4384-83EE-D1B9E4DE6173}" type="datetimeFigureOut">
              <a:rPr lang="zh-TW" altLang="en-US" smtClean="0"/>
              <a:t>2020/3/2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756B7-59D5-49D3-8B1A-DF5E309A7ED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5026274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TW" altLang="en-US" smtClean="0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16FF3-EC6F-4384-83EE-D1B9E4DE6173}" type="datetimeFigureOut">
              <a:rPr lang="zh-TW" altLang="en-US" smtClean="0"/>
              <a:t>2020/3/2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756B7-59D5-49D3-8B1A-DF5E309A7ED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533457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916FF3-EC6F-4384-83EE-D1B9E4DE6173}" type="datetimeFigureOut">
              <a:rPr lang="zh-TW" altLang="en-US" smtClean="0"/>
              <a:t>2020/3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2756B7-59D5-49D3-8B1A-DF5E309A7ED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002816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3"/>
          <p:cNvSpPr txBox="1"/>
          <p:nvPr/>
        </p:nvSpPr>
        <p:spPr>
          <a:xfrm>
            <a:off x="0" y="38912"/>
            <a:ext cx="10014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 smtClean="0">
                <a:latin typeface="Arial" panose="020B0604020202020204" pitchFamily="34" charset="0"/>
                <a:cs typeface="Arial" panose="020B0604020202020204" pitchFamily="34" charset="0"/>
              </a:rPr>
              <a:t>S3A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字方塊 4"/>
          <p:cNvSpPr txBox="1"/>
          <p:nvPr/>
        </p:nvSpPr>
        <p:spPr>
          <a:xfrm>
            <a:off x="2971307" y="617153"/>
            <a:ext cx="13809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i="1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zh-TW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0.123</a:t>
            </a:r>
            <a:endParaRPr lang="zh-TW" altLang="en-US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字方塊 5"/>
          <p:cNvSpPr txBox="1"/>
          <p:nvPr/>
        </p:nvSpPr>
        <p:spPr>
          <a:xfrm>
            <a:off x="2979588" y="356856"/>
            <a:ext cx="13809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i="1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zh-TW" dirty="0" smtClean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0.471</a:t>
            </a:r>
            <a:endParaRPr lang="zh-TW" altLang="en-US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" name="圖表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87824355"/>
              </p:ext>
            </p:extLst>
          </p:nvPr>
        </p:nvGraphicFramePr>
        <p:xfrm>
          <a:off x="86679" y="975058"/>
          <a:ext cx="6721077" cy="39276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圖表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34525264"/>
              </p:ext>
            </p:extLst>
          </p:nvPr>
        </p:nvGraphicFramePr>
        <p:xfrm>
          <a:off x="131324" y="6089513"/>
          <a:ext cx="6579157" cy="33868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0" name="文字方塊 9"/>
          <p:cNvSpPr txBox="1"/>
          <p:nvPr/>
        </p:nvSpPr>
        <p:spPr>
          <a:xfrm>
            <a:off x="2730436" y="6812776"/>
            <a:ext cx="13809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zh-TW" dirty="0" smtClean="0">
                <a:latin typeface="Arial" panose="020B0604020202020204" pitchFamily="34" charset="0"/>
                <a:cs typeface="Arial" panose="020B0604020202020204" pitchFamily="34" charset="0"/>
              </a:rPr>
              <a:t> = 0.319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字方塊 10"/>
          <p:cNvSpPr txBox="1"/>
          <p:nvPr/>
        </p:nvSpPr>
        <p:spPr>
          <a:xfrm>
            <a:off x="-3240" y="5638796"/>
            <a:ext cx="10014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 smtClean="0">
                <a:latin typeface="Arial" panose="020B0604020202020204" pitchFamily="34" charset="0"/>
                <a:cs typeface="Arial" panose="020B0604020202020204" pitchFamily="34" charset="0"/>
              </a:rPr>
              <a:t>S3B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833153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19</TotalTime>
  <Words>13</Words>
  <Application>Microsoft Office PowerPoint</Application>
  <PresentationFormat>A4 紙張 (210x297 公釐)</PresentationFormat>
  <Paragraphs>6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5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7" baseType="lpstr">
      <vt:lpstr>Arial Unicode MS</vt:lpstr>
      <vt:lpstr>新細明體</vt:lpstr>
      <vt:lpstr>Arial</vt:lpstr>
      <vt:lpstr>Calibri</vt:lpstr>
      <vt:lpstr>Calibri Light</vt:lpstr>
      <vt:lpstr>Office 佈景主題</vt:lpstr>
      <vt:lpstr>PowerPoint 簡報</vt:lpstr>
    </vt:vector>
  </TitlesOfParts>
  <Company>Toshiba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chenghsunho</dc:creator>
  <cp:lastModifiedBy>HP 250</cp:lastModifiedBy>
  <cp:revision>235</cp:revision>
  <cp:lastPrinted>2018-07-02T08:11:55Z</cp:lastPrinted>
  <dcterms:created xsi:type="dcterms:W3CDTF">2017-10-31T07:54:33Z</dcterms:created>
  <dcterms:modified xsi:type="dcterms:W3CDTF">2020-03-29T02:20:37Z</dcterms:modified>
</cp:coreProperties>
</file>